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5" r:id="rId2"/>
    <p:sldId id="260" r:id="rId3"/>
    <p:sldId id="261" r:id="rId4"/>
    <p:sldId id="262" r:id="rId5"/>
    <p:sldId id="263" r:id="rId6"/>
    <p:sldId id="264" r:id="rId7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>
        <p:scale>
          <a:sx n="150" d="100"/>
          <a:sy n="150" d="100"/>
        </p:scale>
        <p:origin x="1200" y="-21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5402-06D7-4535-BBED-B3956CE1F904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C9777C-A422-49CE-8968-852810D316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6121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5402-06D7-4535-BBED-B3956CE1F904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C9777C-A422-49CE-8968-852810D316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0481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5402-06D7-4535-BBED-B3956CE1F904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C9777C-A422-49CE-8968-852810D316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06922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5402-06D7-4535-BBED-B3956CE1F904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C9777C-A422-49CE-8968-852810D316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63777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5402-06D7-4535-BBED-B3956CE1F904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C9777C-A422-49CE-8968-852810D316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225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5402-06D7-4535-BBED-B3956CE1F904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C9777C-A422-49CE-8968-852810D316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88428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5402-06D7-4535-BBED-B3956CE1F904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C9777C-A422-49CE-8968-852810D316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2709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5402-06D7-4535-BBED-B3956CE1F904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C9777C-A422-49CE-8968-852810D316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62704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5402-06D7-4535-BBED-B3956CE1F904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C9777C-A422-49CE-8968-852810D316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10035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5402-06D7-4535-BBED-B3956CE1F904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C9777C-A422-49CE-8968-852810D316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13111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5402-06D7-4535-BBED-B3956CE1F904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C9777C-A422-49CE-8968-852810D316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402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CC5402-06D7-4535-BBED-B3956CE1F904}" type="datetimeFigureOut">
              <a:rPr lang="en-GB" smtClean="0"/>
              <a:t>25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C9777C-A422-49CE-8968-852810D316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1618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E77EB164-4EB3-4DD1-A5E0-9B1EA0EFD0F8}"/>
              </a:ext>
            </a:extLst>
          </p:cNvPr>
          <p:cNvSpPr/>
          <p:nvPr/>
        </p:nvSpPr>
        <p:spPr>
          <a:xfrm>
            <a:off x="181673" y="166239"/>
            <a:ext cx="7196328" cy="105255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low cytometric staining of B-cell HLA-DP/DQ/DR and gating strategy for B-cell maturation subsets. 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19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-cells were stained with HLA-DP/DQ/DR or isotype control </a:t>
            </a: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r for CD24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38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,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ith the maturation status of the cells determined by expression levels of the following combinations of markers; immature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CD19</a:t>
            </a:r>
            <a:r>
              <a:rPr lang="en-GB" sz="1200" baseline="30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38</a:t>
            </a:r>
            <a:r>
              <a:rPr lang="en-GB" sz="1200" baseline="30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24</a:t>
            </a:r>
            <a:r>
              <a:rPr lang="en-GB" sz="1200" baseline="30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aïve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CD19</a:t>
            </a:r>
            <a:r>
              <a:rPr lang="en-GB" sz="1200" baseline="30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38</a:t>
            </a:r>
            <a:r>
              <a:rPr lang="en-GB" sz="1200" baseline="30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t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24</a:t>
            </a:r>
            <a:r>
              <a:rPr lang="en-GB" sz="1200" baseline="30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t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emory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CD19</a:t>
            </a:r>
            <a:r>
              <a:rPr lang="en-GB" sz="1200" baseline="30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38</a:t>
            </a:r>
            <a:r>
              <a:rPr lang="en-GB" sz="1200" baseline="30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−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24</a:t>
            </a:r>
            <a:r>
              <a:rPr lang="en-GB" sz="1200" baseline="30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asmablast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19</a:t>
            </a:r>
            <a:r>
              <a:rPr lang="en-GB" sz="1200" baseline="30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38</a:t>
            </a:r>
            <a:r>
              <a:rPr lang="en-GB" sz="1200" baseline="30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−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24</a:t>
            </a:r>
            <a:r>
              <a:rPr lang="en-GB" sz="1200" baseline="300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−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B-cells.</a:t>
            </a:r>
            <a:endParaRPr lang="en-GB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 Suppression of B-cell activation is limited to healthy, but not damaged, RBC.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ior to co-culture, RBC were left untreated, or damaged by heat shock, or by treatment with copper sulphate or calcium ionophore.  HLA-DP/DQ/DR expression was then compared by flow cytometry on CD19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-cells after incubation for 24 hours alone versus in co-culture with healthy RBC or damaged RBC (n=10).  *P&lt;0.05. UT; untreated red blood cells; CuSO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opper sulphate.</a:t>
            </a:r>
            <a:endParaRPr lang="en-GB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  Sialic acid expression by RBC after recombinant </a:t>
            </a:r>
            <a:r>
              <a:rPr lang="en-GB" sz="1200" b="1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ibrio cholerae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neuraminidase or neuraminidase S treatment. 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BC were treated with either a recombinant fragment of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ibrio cholerae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neuraminidase </a:t>
            </a: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r neuraminidase S </a:t>
            </a: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flow cytometry used to determine the expression of α(2,3)- or α(2,6)-linked sialic acid expression on untreated RBC (blue), or enzyme treated RBC (red), based on MAL II and SNA lectin binding respectively and compared to secondary staining only (orange).</a:t>
            </a:r>
            <a:endParaRPr lang="en-GB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.  CD22 and Siglec-10 expression on B-cells from healthy donors or CLL patients. 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low cytometric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termination of </a:t>
            </a: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GB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dividual variation in CD22 expression by CD19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-cells from healthy donors (n=17) and </a:t>
            </a: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22 and Siglec-10 levels by CD19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-cells from CLL patients (n=17) compared to healthy controls (n=17). ****P&gt;0.001, *P&gt;0.05 (Mann Whitney). </a:t>
            </a:r>
            <a:endParaRPr lang="en-GB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5.  RBC suppress activation of CD19</a:t>
            </a:r>
            <a:r>
              <a:rPr lang="en-GB" sz="1200" b="1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5</a:t>
            </a:r>
            <a:r>
              <a:rPr lang="en-GB" sz="1200" b="1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-cells from healthy donors and autoantigen presentation by CLL B-cells from some CLL patients.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19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-cells were isolated from healthy donors and RBC added to the cultures at ratios of 1:1, 1:10 or 1:100 and incubated for 24 hours before using flow cytometry to determine the levels of HLA-DP/DQ/DR on CD19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5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-cells (n=10) (Friedman). </a:t>
            </a: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percentage of CFSE labelled CD4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-cells having undergone cell division was determined by flow cytometry and used as a measure of B-cell antigen presentation in co-cultures of T-cells after B-cells had been pulsed with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hD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otein autoantigen in the presence or absence of 1:100 RBC, for patients with uncomplicated CLL (black line, n=8) or CLL plus secondary autoimmune haemolytic anaemia (red line, n=3). B, B-cell; RBC, 1:100 red blood cells; T, T-cell</a:t>
            </a:r>
            <a:endParaRPr lang="en-GB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2794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50" name="Group 2049">
            <a:extLst>
              <a:ext uri="{FF2B5EF4-FFF2-40B4-BE49-F238E27FC236}">
                <a16:creationId xmlns:a16="http://schemas.microsoft.com/office/drawing/2014/main" xmlns="" id="{FAEE0A93-4516-478A-9429-E9ADE6CDC163}"/>
              </a:ext>
            </a:extLst>
          </p:cNvPr>
          <p:cNvGrpSpPr/>
          <p:nvPr/>
        </p:nvGrpSpPr>
        <p:grpSpPr>
          <a:xfrm>
            <a:off x="805815" y="2178844"/>
            <a:ext cx="5948045" cy="6334126"/>
            <a:chOff x="805815" y="2178844"/>
            <a:chExt cx="5948045" cy="6334126"/>
          </a:xfrm>
        </p:grpSpPr>
        <p:sp>
          <p:nvSpPr>
            <p:cNvPr id="24" name="Text Box 2">
              <a:extLst>
                <a:ext uri="{FF2B5EF4-FFF2-40B4-BE49-F238E27FC236}">
                  <a16:creationId xmlns:a16="http://schemas.microsoft.com/office/drawing/2014/main" xmlns="" id="{F9B05870-89AF-4CA8-876A-90D3050470E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05815" y="2178844"/>
              <a:ext cx="3028950" cy="42164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ysClr val="window" lastClr="FFFFFF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4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ry Figure 1</a:t>
              </a:r>
              <a:endParaRPr lang="en-GB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xmlns="" id="{E037CFFE-CE50-46E7-BDAE-E1B07E80E5E1}"/>
                </a:ext>
              </a:extLst>
            </p:cNvPr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10710" y="3668554"/>
              <a:ext cx="2343150" cy="2383155"/>
            </a:xfrm>
            <a:prstGeom prst="rect">
              <a:avLst/>
            </a:prstGeom>
            <a:noFill/>
          </p:spPr>
        </p:pic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xmlns="" id="{DA8F88C7-65A4-43F2-95F6-95A4D55C54F5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473200" y="3684429"/>
              <a:ext cx="2345055" cy="4828541"/>
              <a:chOff x="-68785" y="0"/>
              <a:chExt cx="3348548" cy="6894711"/>
            </a:xfrm>
          </p:grpSpPr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xmlns="" id="{5E0DC2FF-E190-41B1-92EF-2A0ADAC433D7}"/>
                  </a:ext>
                </a:extLst>
              </p:cNvPr>
              <p:cNvGrpSpPr/>
              <p:nvPr/>
            </p:nvGrpSpPr>
            <p:grpSpPr>
              <a:xfrm>
                <a:off x="-68785" y="3457090"/>
                <a:ext cx="3348548" cy="3437621"/>
                <a:chOff x="-68785" y="3457090"/>
                <a:chExt cx="3348548" cy="3437621"/>
              </a:xfrm>
            </p:grpSpPr>
            <p:sp>
              <p:nvSpPr>
                <p:cNvPr id="36" name="TextBox 14">
                  <a:extLst>
                    <a:ext uri="{FF2B5EF4-FFF2-40B4-BE49-F238E27FC236}">
                      <a16:creationId xmlns:a16="http://schemas.microsoft.com/office/drawing/2014/main" xmlns="" id="{E9B847CD-79ED-40FA-8743-B20EA8377AA2}"/>
                    </a:ext>
                  </a:extLst>
                </p:cNvPr>
                <p:cNvSpPr txBox="1"/>
                <p:nvPr/>
              </p:nvSpPr>
              <p:spPr>
                <a:xfrm>
                  <a:off x="545985" y="6480056"/>
                  <a:ext cx="890270" cy="4146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15000"/>
                    </a:lnSpc>
                    <a:spcBef>
                      <a:spcPts val="0"/>
                    </a:spcBef>
                    <a:spcAft>
                      <a:spcPts val="10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1100" b="0" i="0" u="none" strike="noStrike" kern="1200" cap="none" spc="0" normalizeH="0" baseline="0" noProof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CD19</a:t>
                  </a:r>
                  <a:endParaRPr kumimoji="0" lang="en-GB" sz="11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TextBox 17">
                  <a:extLst>
                    <a:ext uri="{FF2B5EF4-FFF2-40B4-BE49-F238E27FC236}">
                      <a16:creationId xmlns:a16="http://schemas.microsoft.com/office/drawing/2014/main" xmlns="" id="{7199AFD0-F142-470A-B43B-0FD12784DD9E}"/>
                    </a:ext>
                  </a:extLst>
                </p:cNvPr>
                <p:cNvSpPr txBox="1"/>
                <p:nvPr/>
              </p:nvSpPr>
              <p:spPr>
                <a:xfrm rot="16200000">
                  <a:off x="-808242" y="5500345"/>
                  <a:ext cx="1893570" cy="4146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15000"/>
                    </a:lnSpc>
                    <a:spcBef>
                      <a:spcPts val="0"/>
                    </a:spcBef>
                    <a:spcAft>
                      <a:spcPts val="10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1100" b="0" i="0" u="none" strike="noStrike" kern="1200" cap="none" spc="0" normalizeH="0" baseline="0" noProof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Mouse IgG2a</a:t>
                  </a:r>
                  <a:endParaRPr kumimoji="0" lang="en-GB" sz="11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38" name="Picture 37">
                  <a:extLst>
                    <a:ext uri="{FF2B5EF4-FFF2-40B4-BE49-F238E27FC236}">
                      <a16:creationId xmlns:a16="http://schemas.microsoft.com/office/drawing/2014/main" xmlns="" id="{C9D6200B-0ACD-4C7E-8B98-FA2CF2094B5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5753" b="5927"/>
                <a:stretch/>
              </p:blipFill>
              <p:spPr>
                <a:xfrm>
                  <a:off x="407106" y="3457090"/>
                  <a:ext cx="2872657" cy="2822548"/>
                </a:xfrm>
                <a:prstGeom prst="rect">
                  <a:avLst/>
                </a:prstGeom>
              </p:spPr>
            </p:pic>
            <p:grpSp>
              <p:nvGrpSpPr>
                <p:cNvPr id="39" name="Group 38">
                  <a:extLst>
                    <a:ext uri="{FF2B5EF4-FFF2-40B4-BE49-F238E27FC236}">
                      <a16:creationId xmlns:a16="http://schemas.microsoft.com/office/drawing/2014/main" xmlns="" id="{22384EA5-09C1-4CAF-B84D-AC7268A86952}"/>
                    </a:ext>
                  </a:extLst>
                </p:cNvPr>
                <p:cNvGrpSpPr/>
                <p:nvPr/>
              </p:nvGrpSpPr>
              <p:grpSpPr>
                <a:xfrm>
                  <a:off x="410527" y="5639257"/>
                  <a:ext cx="1026254" cy="724329"/>
                  <a:chOff x="410527" y="5639257"/>
                  <a:chExt cx="1026254" cy="724329"/>
                </a:xfrm>
              </p:grpSpPr>
              <p:cxnSp>
                <p:nvCxnSpPr>
                  <p:cNvPr id="40" name="Straight Arrow Connector 39">
                    <a:extLst>
                      <a:ext uri="{FF2B5EF4-FFF2-40B4-BE49-F238E27FC236}">
                        <a16:creationId xmlns:a16="http://schemas.microsoft.com/office/drawing/2014/main" xmlns="" id="{B7F62724-8E1B-435A-95E9-0C71E3662583}"/>
                      </a:ext>
                    </a:extLst>
                  </p:cNvPr>
                  <p:cNvCxnSpPr/>
                  <p:nvPr/>
                </p:nvCxnSpPr>
                <p:spPr>
                  <a:xfrm>
                    <a:off x="410527" y="6363586"/>
                    <a:ext cx="1026254" cy="0"/>
                  </a:xfrm>
                  <a:prstGeom prst="straightConnector1">
                    <a:avLst/>
                  </a:prstGeom>
                  <a:noFill/>
                  <a:ln w="3175" cap="flat" cmpd="sng" algn="ctr">
                    <a:solidFill>
                      <a:sysClr val="windowText" lastClr="000000">
                        <a:shade val="95000"/>
                        <a:satMod val="105000"/>
                      </a:sysClr>
                    </a:solidFill>
                    <a:prstDash val="solid"/>
                    <a:tailEnd type="triangle"/>
                  </a:ln>
                  <a:effectLst/>
                </p:spPr>
              </p:cxnSp>
              <p:cxnSp>
                <p:nvCxnSpPr>
                  <p:cNvPr id="41" name="Straight Arrow Connector 40">
                    <a:extLst>
                      <a:ext uri="{FF2B5EF4-FFF2-40B4-BE49-F238E27FC236}">
                        <a16:creationId xmlns:a16="http://schemas.microsoft.com/office/drawing/2014/main" xmlns="" id="{FAB22C87-2940-4378-A9F1-FABCB138FDA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410527" y="5639257"/>
                    <a:ext cx="0" cy="724329"/>
                  </a:xfrm>
                  <a:prstGeom prst="straightConnector1">
                    <a:avLst/>
                  </a:prstGeom>
                  <a:noFill/>
                  <a:ln w="3175" cap="flat" cmpd="sng" algn="ctr">
                    <a:solidFill>
                      <a:sysClr val="windowText" lastClr="000000">
                        <a:shade val="95000"/>
                        <a:satMod val="105000"/>
                      </a:sysClr>
                    </a:solidFill>
                    <a:prstDash val="solid"/>
                    <a:tailEnd type="triangle"/>
                  </a:ln>
                  <a:effectLst/>
                </p:spPr>
              </p:cxnSp>
            </p:grpSp>
          </p:grpSp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xmlns="" id="{4142B0F2-6FD4-4E6C-BBB9-82CE146585B7}"/>
                  </a:ext>
                </a:extLst>
              </p:cNvPr>
              <p:cNvGrpSpPr/>
              <p:nvPr/>
            </p:nvGrpSpPr>
            <p:grpSpPr>
              <a:xfrm>
                <a:off x="-68577" y="0"/>
                <a:ext cx="3348340" cy="3446792"/>
                <a:chOff x="-68577" y="0"/>
                <a:chExt cx="3348340" cy="3446792"/>
              </a:xfrm>
            </p:grpSpPr>
            <p:pic>
              <p:nvPicPr>
                <p:cNvPr id="29" name="Picture 28">
                  <a:extLst>
                    <a:ext uri="{FF2B5EF4-FFF2-40B4-BE49-F238E27FC236}">
                      <a16:creationId xmlns:a16="http://schemas.microsoft.com/office/drawing/2014/main" xmlns="" id="{562AAB86-5944-4BAE-80A1-B498891F646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5753" b="5920"/>
                <a:stretch/>
              </p:blipFill>
              <p:spPr>
                <a:xfrm>
                  <a:off x="407106" y="0"/>
                  <a:ext cx="2872657" cy="2822770"/>
                </a:xfrm>
                <a:prstGeom prst="rect">
                  <a:avLst/>
                </a:prstGeom>
              </p:spPr>
            </p:pic>
            <p:grpSp>
              <p:nvGrpSpPr>
                <p:cNvPr id="30" name="Group 29">
                  <a:extLst>
                    <a:ext uri="{FF2B5EF4-FFF2-40B4-BE49-F238E27FC236}">
                      <a16:creationId xmlns:a16="http://schemas.microsoft.com/office/drawing/2014/main" xmlns="" id="{F5CCE455-22FF-49D5-A656-507704D91D07}"/>
                    </a:ext>
                  </a:extLst>
                </p:cNvPr>
                <p:cNvGrpSpPr/>
                <p:nvPr/>
              </p:nvGrpSpPr>
              <p:grpSpPr>
                <a:xfrm>
                  <a:off x="-68577" y="1312655"/>
                  <a:ext cx="1505536" cy="2134137"/>
                  <a:chOff x="-68577" y="1312655"/>
                  <a:chExt cx="1505536" cy="2134137"/>
                </a:xfrm>
              </p:grpSpPr>
              <p:sp>
                <p:nvSpPr>
                  <p:cNvPr id="31" name="TextBox 19">
                    <a:extLst>
                      <a:ext uri="{FF2B5EF4-FFF2-40B4-BE49-F238E27FC236}">
                        <a16:creationId xmlns:a16="http://schemas.microsoft.com/office/drawing/2014/main" xmlns="" id="{9D2775B4-4467-41CC-A912-CA81D8AEB293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808352" y="2052430"/>
                    <a:ext cx="1894205" cy="4146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15000"/>
                      </a:lnSpc>
                      <a:spcBef>
                        <a:spcPts val="0"/>
                      </a:spcBef>
                      <a:spcAft>
                        <a:spcPts val="100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GB" sz="11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HLA-DP/DQ/DR</a:t>
                    </a:r>
                    <a:endParaRPr kumimoji="0" lang="en-GB" sz="1100" b="0" i="0" u="none" strike="noStrike" kern="0" cap="none" spc="0" normalizeH="0" baseline="0" noProof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2" name="TextBox 20">
                    <a:extLst>
                      <a:ext uri="{FF2B5EF4-FFF2-40B4-BE49-F238E27FC236}">
                        <a16:creationId xmlns:a16="http://schemas.microsoft.com/office/drawing/2014/main" xmlns="" id="{9C10802F-CF0A-4DB7-97CA-04C9780D5D5B}"/>
                      </a:ext>
                    </a:extLst>
                  </p:cNvPr>
                  <p:cNvSpPr txBox="1"/>
                  <p:nvPr/>
                </p:nvSpPr>
                <p:spPr>
                  <a:xfrm>
                    <a:off x="546054" y="3032137"/>
                    <a:ext cx="890905" cy="4146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15000"/>
                      </a:lnSpc>
                      <a:spcBef>
                        <a:spcPts val="0"/>
                      </a:spcBef>
                      <a:spcAft>
                        <a:spcPts val="100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GB" sz="11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CD19</a:t>
                    </a:r>
                    <a:endParaRPr kumimoji="0" lang="en-GB" sz="1100" b="0" i="0" u="none" strike="noStrike" kern="0" cap="none" spc="0" normalizeH="0" baseline="0" noProof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33" name="Group 32">
                    <a:extLst>
                      <a:ext uri="{FF2B5EF4-FFF2-40B4-BE49-F238E27FC236}">
                        <a16:creationId xmlns:a16="http://schemas.microsoft.com/office/drawing/2014/main" xmlns="" id="{B9833310-53C6-4B1D-A9C3-BDABEF8C1718}"/>
                      </a:ext>
                    </a:extLst>
                  </p:cNvPr>
                  <p:cNvGrpSpPr/>
                  <p:nvPr/>
                </p:nvGrpSpPr>
                <p:grpSpPr>
                  <a:xfrm>
                    <a:off x="410527" y="2191085"/>
                    <a:ext cx="1026254" cy="724329"/>
                    <a:chOff x="410527" y="2191085"/>
                    <a:chExt cx="1026254" cy="724329"/>
                  </a:xfrm>
                </p:grpSpPr>
                <p:cxnSp>
                  <p:nvCxnSpPr>
                    <p:cNvPr id="34" name="Straight Arrow Connector 33">
                      <a:extLst>
                        <a:ext uri="{FF2B5EF4-FFF2-40B4-BE49-F238E27FC236}">
                          <a16:creationId xmlns:a16="http://schemas.microsoft.com/office/drawing/2014/main" xmlns="" id="{6BC45927-78EB-4F5F-881B-126471A49E9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10527" y="2915414"/>
                      <a:ext cx="1026254" cy="0"/>
                    </a:xfrm>
                    <a:prstGeom prst="straightConnector1">
                      <a:avLst/>
                    </a:prstGeom>
                    <a:noFill/>
                    <a:ln w="3175" cap="flat" cmpd="sng" algn="ctr">
                      <a:solidFill>
                        <a:sysClr val="windowText" lastClr="000000">
                          <a:shade val="95000"/>
                          <a:satMod val="105000"/>
                        </a:sysClr>
                      </a:solidFill>
                      <a:prstDash val="solid"/>
                      <a:tailEnd type="triangle"/>
                    </a:ln>
                    <a:effectLst/>
                  </p:spPr>
                </p:cxnSp>
                <p:cxnSp>
                  <p:nvCxnSpPr>
                    <p:cNvPr id="35" name="Straight Arrow Connector 34">
                      <a:extLst>
                        <a:ext uri="{FF2B5EF4-FFF2-40B4-BE49-F238E27FC236}">
                          <a16:creationId xmlns:a16="http://schemas.microsoft.com/office/drawing/2014/main" xmlns="" id="{3992A119-C8CE-4CAE-AC2E-D6AFC6A756E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410527" y="2191085"/>
                      <a:ext cx="0" cy="724329"/>
                    </a:xfrm>
                    <a:prstGeom prst="straightConnector1">
                      <a:avLst/>
                    </a:prstGeom>
                    <a:noFill/>
                    <a:ln w="3175" cap="flat" cmpd="sng" algn="ctr">
                      <a:solidFill>
                        <a:sysClr val="windowText" lastClr="000000">
                          <a:shade val="95000"/>
                          <a:satMod val="105000"/>
                        </a:sysClr>
                      </a:solidFill>
                      <a:prstDash val="solid"/>
                      <a:tailEnd type="triangle"/>
                    </a:ln>
                    <a:effectLst/>
                  </p:spPr>
                </p:cxnSp>
              </p:grpSp>
            </p:grpSp>
          </p:grpSp>
        </p:grp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xmlns="" id="{80DFAD59-7C13-4735-A65A-49ADB9FF1FC6}"/>
                </a:ext>
              </a:extLst>
            </p:cNvPr>
            <p:cNvSpPr/>
            <p:nvPr/>
          </p:nvSpPr>
          <p:spPr>
            <a:xfrm>
              <a:off x="1977729" y="3133576"/>
              <a:ext cx="325602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400" b="1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GB" sz="1400" b="1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r>
                <a:rPr lang="en-GB" sz="1400" b="1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						     </a:t>
              </a:r>
              <a:r>
                <a:rPr lang="en-GB" sz="1400" b="1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21142659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xmlns="" id="{66C09DD4-5C7E-40FC-A010-7DF3891FCC4C}"/>
              </a:ext>
            </a:extLst>
          </p:cNvPr>
          <p:cNvGrpSpPr/>
          <p:nvPr/>
        </p:nvGrpSpPr>
        <p:grpSpPr>
          <a:xfrm>
            <a:off x="2265362" y="2741771"/>
            <a:ext cx="3028950" cy="5208270"/>
            <a:chOff x="2265362" y="2741771"/>
            <a:chExt cx="3028950" cy="5208270"/>
          </a:xfrm>
        </p:grpSpPr>
        <p:sp>
          <p:nvSpPr>
            <p:cNvPr id="2" name="Text Box 2">
              <a:extLst>
                <a:ext uri="{FF2B5EF4-FFF2-40B4-BE49-F238E27FC236}">
                  <a16:creationId xmlns:a16="http://schemas.microsoft.com/office/drawing/2014/main" xmlns="" id="{4CB5421F-8409-464B-9D25-D56BF292247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76917" y="3445351"/>
              <a:ext cx="1288415" cy="26416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ysClr val="window" lastClr="FFFFFF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2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LA DP/DQ/DR</a:t>
              </a:r>
              <a:endParaRPr lang="en-GB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Text Box 2">
              <a:extLst>
                <a:ext uri="{FF2B5EF4-FFF2-40B4-BE49-F238E27FC236}">
                  <a16:creationId xmlns:a16="http://schemas.microsoft.com/office/drawing/2014/main" xmlns="" id="{629F054D-9407-4A35-AB0F-E1FCE13166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65362" y="2741771"/>
              <a:ext cx="3028950" cy="42164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ysClr val="window" lastClr="FFFFFF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ry Figure 2</a:t>
              </a:r>
              <a:endPara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xmlns="" id="{F2F0EC41-33C7-4FEC-B3C5-9E69AB6D7741}"/>
                </a:ext>
              </a:extLst>
            </p:cNvPr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65362" y="3797776"/>
              <a:ext cx="3018790" cy="415226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6391039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xmlns="" id="{6C083D1E-17F4-44AE-AC19-9A62F097B052}"/>
              </a:ext>
            </a:extLst>
          </p:cNvPr>
          <p:cNvGrpSpPr/>
          <p:nvPr/>
        </p:nvGrpSpPr>
        <p:grpSpPr>
          <a:xfrm>
            <a:off x="1574482" y="2229326"/>
            <a:ext cx="4410710" cy="6233160"/>
            <a:chOff x="1574482" y="2229326"/>
            <a:chExt cx="4410710" cy="6233160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xmlns="" id="{F3AE7589-1F2A-4CAF-8A67-C30532A01D5F}"/>
                </a:ext>
              </a:extLst>
            </p:cNvPr>
            <p:cNvGrpSpPr/>
            <p:nvPr/>
          </p:nvGrpSpPr>
          <p:grpSpPr>
            <a:xfrm>
              <a:off x="3774757" y="3258026"/>
              <a:ext cx="2210435" cy="2298700"/>
              <a:chOff x="0" y="0"/>
              <a:chExt cx="2210435" cy="2298700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xmlns="" id="{F492C7FB-9593-4569-9766-CED3D40ABA5B}"/>
                  </a:ext>
                </a:extLst>
              </p:cNvPr>
              <p:cNvPicPr>
                <a:picLocks noGrp="1"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16" t="525" r="36483" b="5190"/>
              <a:stretch/>
            </p:blipFill>
            <p:spPr bwMode="auto">
              <a:xfrm>
                <a:off x="0" y="219075"/>
                <a:ext cx="2210435" cy="2079625"/>
              </a:xfrm>
              <a:prstGeom prst="rect">
                <a:avLst/>
              </a:prstGeom>
              <a:noFill/>
              <a:ln>
                <a:noFill/>
              </a:ln>
              <a:effectLst/>
            </p:spPr>
          </p:pic>
          <p:sp>
            <p:nvSpPr>
              <p:cNvPr id="16" name="Text Box 2">
                <a:extLst>
                  <a:ext uri="{FF2B5EF4-FFF2-40B4-BE49-F238E27FC236}">
                    <a16:creationId xmlns:a16="http://schemas.microsoft.com/office/drawing/2014/main" xmlns="" id="{00FB7F85-56F0-4D21-A0DE-6F3CA457D31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81000" y="0"/>
                <a:ext cx="1828800" cy="271145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ysClr val="window" lastClr="FFFFFF"/>
                </a:solidFill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1200" b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α(2-6)-linked sialic acids</a:t>
                </a:r>
                <a:endParaRPr lang="en-GB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xmlns="" id="{2A019E33-7596-43F2-84D1-EA3E20211D97}"/>
                </a:ext>
              </a:extLst>
            </p:cNvPr>
            <p:cNvGrpSpPr/>
            <p:nvPr/>
          </p:nvGrpSpPr>
          <p:grpSpPr>
            <a:xfrm>
              <a:off x="1575752" y="3258026"/>
              <a:ext cx="2150110" cy="2268855"/>
              <a:chOff x="0" y="0"/>
              <a:chExt cx="2150110" cy="2268855"/>
            </a:xfrm>
          </p:grpSpPr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xmlns="" id="{2E60E61F-94DC-4A80-B97B-59DC59981E5A}"/>
                  </a:ext>
                </a:extLst>
              </p:cNvPr>
              <p:cNvPicPr>
                <a:picLocks noGrp="1"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307" r="36067" b="5362"/>
              <a:stretch/>
            </p:blipFill>
            <p:spPr bwMode="auto">
              <a:xfrm>
                <a:off x="0" y="219075"/>
                <a:ext cx="2150110" cy="2049780"/>
              </a:xfrm>
              <a:prstGeom prst="rect">
                <a:avLst/>
              </a:prstGeom>
              <a:noFill/>
              <a:ln>
                <a:noFill/>
              </a:ln>
              <a:effectLst/>
            </p:spPr>
          </p:pic>
          <p:sp>
            <p:nvSpPr>
              <p:cNvPr id="14" name="Text Box 2">
                <a:extLst>
                  <a:ext uri="{FF2B5EF4-FFF2-40B4-BE49-F238E27FC236}">
                    <a16:creationId xmlns:a16="http://schemas.microsoft.com/office/drawing/2014/main" xmlns="" id="{041AD19C-2963-47B0-A5E3-DB7A7C0032B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19075" y="0"/>
                <a:ext cx="1828800" cy="271145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ysClr val="window" lastClr="FFFFFF"/>
                </a:solidFill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12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α(2-3)-linked sialic acids</a:t>
                </a:r>
                <a:endParaRPr lang="en-GB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xmlns="" id="{98B951C4-F106-4B19-A512-B62A24EBB41F}"/>
                </a:ext>
              </a:extLst>
            </p:cNvPr>
            <p:cNvGrpSpPr/>
            <p:nvPr/>
          </p:nvGrpSpPr>
          <p:grpSpPr>
            <a:xfrm>
              <a:off x="3774757" y="6125051"/>
              <a:ext cx="2089785" cy="2306955"/>
              <a:chOff x="0" y="0"/>
              <a:chExt cx="2089785" cy="2306955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xmlns="" id="{DB4F5736-95D9-4AF0-8E23-3177B662BA5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25" r="44316" b="6401"/>
              <a:stretch/>
            </p:blipFill>
            <p:spPr bwMode="auto">
              <a:xfrm>
                <a:off x="0" y="257175"/>
                <a:ext cx="2089785" cy="2049780"/>
              </a:xfrm>
              <a:prstGeom prst="rect">
                <a:avLst/>
              </a:prstGeom>
              <a:noFill/>
              <a:ln>
                <a:noFill/>
              </a:ln>
              <a:effectLst/>
            </p:spPr>
          </p:pic>
          <p:sp>
            <p:nvSpPr>
              <p:cNvPr id="12" name="Text Box 2">
                <a:extLst>
                  <a:ext uri="{FF2B5EF4-FFF2-40B4-BE49-F238E27FC236}">
                    <a16:creationId xmlns:a16="http://schemas.microsoft.com/office/drawing/2014/main" xmlns="" id="{75CFAB8D-C93C-460B-9EF1-CBEEF734713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61925" y="0"/>
                <a:ext cx="1828800" cy="271145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ysClr val="window" lastClr="FFFFFF"/>
                </a:solidFill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1200" b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α(2-6)-linked sialic acids</a:t>
                </a:r>
                <a:endParaRPr lang="en-GB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xmlns="" id="{59C43D6F-E0CE-470E-9D47-1E5DF2E31DDF}"/>
                </a:ext>
              </a:extLst>
            </p:cNvPr>
            <p:cNvGrpSpPr/>
            <p:nvPr/>
          </p:nvGrpSpPr>
          <p:grpSpPr>
            <a:xfrm>
              <a:off x="1574482" y="6106001"/>
              <a:ext cx="2179955" cy="2356485"/>
              <a:chOff x="0" y="0"/>
              <a:chExt cx="2179955" cy="2356485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xmlns="" id="{2C66BE2C-F08A-4168-A511-17552D37879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30" r="44317" b="4441"/>
              <a:stretch/>
            </p:blipFill>
            <p:spPr bwMode="auto">
              <a:xfrm>
                <a:off x="0" y="266700"/>
                <a:ext cx="2179955" cy="2089785"/>
              </a:xfrm>
              <a:prstGeom prst="rect">
                <a:avLst/>
              </a:prstGeom>
              <a:noFill/>
              <a:ln>
                <a:noFill/>
              </a:ln>
              <a:effectLst/>
            </p:spPr>
          </p:pic>
          <p:sp>
            <p:nvSpPr>
              <p:cNvPr id="10" name="Text Box 2">
                <a:extLst>
                  <a:ext uri="{FF2B5EF4-FFF2-40B4-BE49-F238E27FC236}">
                    <a16:creationId xmlns:a16="http://schemas.microsoft.com/office/drawing/2014/main" xmlns="" id="{F0544769-1762-49AC-BC15-112FB75FA12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8125" y="0"/>
                <a:ext cx="1828800" cy="271145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ysClr val="window" lastClr="FFFFFF"/>
                </a:solidFill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n-GB" sz="1200" b="1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α(2-3)-linked sialic acids</a:t>
                </a:r>
                <a:endParaRPr lang="en-GB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" name="Text Box 2">
              <a:extLst>
                <a:ext uri="{FF2B5EF4-FFF2-40B4-BE49-F238E27FC236}">
                  <a16:creationId xmlns:a16="http://schemas.microsoft.com/office/drawing/2014/main" xmlns="" id="{586C554E-AA0D-4337-84EC-6B86FE5A45A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74482" y="2229326"/>
              <a:ext cx="3028950" cy="42164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ysClr val="window" lastClr="FFFFFF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ry Figure 3</a:t>
              </a:r>
              <a:endPara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 Box 2">
              <a:extLst>
                <a:ext uri="{FF2B5EF4-FFF2-40B4-BE49-F238E27FC236}">
                  <a16:creationId xmlns:a16="http://schemas.microsoft.com/office/drawing/2014/main" xmlns="" id="{A7B551FC-BBA7-42AE-8648-D9444E2B427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74482" y="2848451"/>
              <a:ext cx="400050" cy="42164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ysClr val="window" lastClr="FFFFFF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4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endPara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 Box 2">
              <a:extLst>
                <a:ext uri="{FF2B5EF4-FFF2-40B4-BE49-F238E27FC236}">
                  <a16:creationId xmlns:a16="http://schemas.microsoft.com/office/drawing/2014/main" xmlns="" id="{7CEFE55E-722E-4B6D-B4A2-6A6999527A1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74482" y="5647531"/>
              <a:ext cx="400050" cy="42164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ysClr val="window" lastClr="FFFFFF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4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endPara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142900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xmlns="" id="{AC755A5B-BBE2-488D-85BE-47DDA0F74AC8}"/>
              </a:ext>
            </a:extLst>
          </p:cNvPr>
          <p:cNvGrpSpPr/>
          <p:nvPr/>
        </p:nvGrpSpPr>
        <p:grpSpPr>
          <a:xfrm>
            <a:off x="987869" y="2533808"/>
            <a:ext cx="5730240" cy="5624195"/>
            <a:chOff x="914717" y="2533809"/>
            <a:chExt cx="5730240" cy="5624195"/>
          </a:xfrm>
        </p:grpSpPr>
        <p:sp>
          <p:nvSpPr>
            <p:cNvPr id="2" name="Text Box 2">
              <a:extLst>
                <a:ext uri="{FF2B5EF4-FFF2-40B4-BE49-F238E27FC236}">
                  <a16:creationId xmlns:a16="http://schemas.microsoft.com/office/drawing/2014/main" xmlns="" id="{F446782F-C8FB-4A4B-9605-F7253ADA4F5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14717" y="2533809"/>
              <a:ext cx="2743200" cy="35496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ysClr val="window" lastClr="FFFFFF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4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ry Figure 4 </a:t>
              </a:r>
              <a:endParaRPr lang="en-GB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Text Box 2">
              <a:extLst>
                <a:ext uri="{FF2B5EF4-FFF2-40B4-BE49-F238E27FC236}">
                  <a16:creationId xmlns:a16="http://schemas.microsoft.com/office/drawing/2014/main" xmlns="" id="{1F6FBA32-FE06-452A-A053-6B67B5F4565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14717" y="3086894"/>
              <a:ext cx="400050" cy="42164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ysClr val="window" lastClr="FFFFFF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4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endPara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 Box 2">
              <a:extLst>
                <a:ext uri="{FF2B5EF4-FFF2-40B4-BE49-F238E27FC236}">
                  <a16:creationId xmlns:a16="http://schemas.microsoft.com/office/drawing/2014/main" xmlns="" id="{F87CA6AC-0D1D-4BC5-A52A-AA2DDFD5652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14717" y="5562124"/>
              <a:ext cx="400050" cy="42164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ysClr val="window" lastClr="FFFFFF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4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endPara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xmlns="" id="{427C56AE-0F0C-4F1C-9150-B38CE6BA9D7D}"/>
                </a:ext>
              </a:extLst>
            </p:cNvPr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14717" y="3483769"/>
              <a:ext cx="2773045" cy="205105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xmlns="" id="{281BF0F7-08B7-4D7D-A3F6-7FF3511A8ECB}"/>
                </a:ext>
              </a:extLst>
            </p:cNvPr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14717" y="5804694"/>
              <a:ext cx="3008059" cy="235331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xmlns="" id="{252F7988-6665-40CA-AEC3-0A784D246497}"/>
                </a:ext>
              </a:extLst>
            </p:cNvPr>
            <p:cNvPicPr/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12527" y="5804694"/>
              <a:ext cx="2932430" cy="235331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554450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xmlns="" id="{3FE04C4E-919D-4A02-88FD-DC4287872282}"/>
              </a:ext>
            </a:extLst>
          </p:cNvPr>
          <p:cNvGrpSpPr/>
          <p:nvPr/>
        </p:nvGrpSpPr>
        <p:grpSpPr>
          <a:xfrm>
            <a:off x="1072197" y="3140551"/>
            <a:ext cx="5415280" cy="4410710"/>
            <a:chOff x="1072197" y="3140551"/>
            <a:chExt cx="5415280" cy="4410710"/>
          </a:xfrm>
        </p:grpSpPr>
        <p:sp>
          <p:nvSpPr>
            <p:cNvPr id="2" name="Text Box 2">
              <a:extLst>
                <a:ext uri="{FF2B5EF4-FFF2-40B4-BE49-F238E27FC236}">
                  <a16:creationId xmlns:a16="http://schemas.microsoft.com/office/drawing/2014/main" xmlns="" id="{E081BDEC-B681-4493-A0C3-5DC81C3ADB0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03007" y="3140551"/>
              <a:ext cx="2743200" cy="35496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ysClr val="window" lastClr="FFFFFF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4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ry Figure 5 </a:t>
              </a:r>
              <a:endParaRPr lang="en-GB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05C9E7AA-FA86-40C0-931C-2F00F9B0A57C}"/>
                </a:ext>
              </a:extLst>
            </p:cNvPr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03007" y="5003641"/>
              <a:ext cx="2534285" cy="2453005"/>
            </a:xfrm>
            <a:prstGeom prst="rect">
              <a:avLst/>
            </a:prstGeom>
          </p:spPr>
        </p:pic>
        <p:sp>
          <p:nvSpPr>
            <p:cNvPr id="4" name="Text Box 2">
              <a:extLst>
                <a:ext uri="{FF2B5EF4-FFF2-40B4-BE49-F238E27FC236}">
                  <a16:creationId xmlns:a16="http://schemas.microsoft.com/office/drawing/2014/main" xmlns="" id="{18468A80-07A0-48C1-B070-B61B24D5782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72197" y="4164806"/>
              <a:ext cx="5415280" cy="42164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ysClr val="window" lastClr="FFFFFF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  </a:t>
              </a:r>
              <a:r>
                <a:rPr lang="en-GB" sz="14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r>
                <a:rPr lang="en-GB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						</a:t>
              </a:r>
              <a:r>
                <a:rPr lang="en-GB" sz="14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endPara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xmlns="" id="{24EB1533-4044-4B07-9864-CB0186817BDC}"/>
                </a:ext>
              </a:extLst>
            </p:cNvPr>
            <p:cNvPicPr/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781"/>
            <a:stretch/>
          </p:blipFill>
          <p:spPr bwMode="auto">
            <a:xfrm>
              <a:off x="3778567" y="5088096"/>
              <a:ext cx="2670175" cy="2463165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6" name="Text Box 32">
              <a:extLst>
                <a:ext uri="{FF2B5EF4-FFF2-40B4-BE49-F238E27FC236}">
                  <a16:creationId xmlns:a16="http://schemas.microsoft.com/office/drawing/2014/main" xmlns="" id="{EBA6785E-93BA-4C58-A55A-C5671211DC0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34832" y="4692491"/>
              <a:ext cx="1254760" cy="30924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ysClr val="window" lastClr="FFFFFF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200" b="1">
                  <a:ln>
                    <a:noFill/>
                  </a:ln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LA-DP/DQ/DR</a:t>
              </a:r>
              <a:endParaRPr lang="en-GB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890249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9</TotalTime>
  <Words>547</Words>
  <Application>Microsoft Office PowerPoint</Application>
  <PresentationFormat>Custom</PresentationFormat>
  <Paragraphs>2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ker, Robert</dc:creator>
  <cp:lastModifiedBy>Hari hara sudhan K.</cp:lastModifiedBy>
  <cp:revision>13</cp:revision>
  <dcterms:created xsi:type="dcterms:W3CDTF">2021-03-10T18:01:38Z</dcterms:created>
  <dcterms:modified xsi:type="dcterms:W3CDTF">2021-03-25T16:07:28Z</dcterms:modified>
</cp:coreProperties>
</file>